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39" d="100"/>
          <a:sy n="139" d="100"/>
        </p:scale>
        <p:origin x="666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7130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126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6377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2079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5128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8502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38540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293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0354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7659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745FF5-E7E1-4D35-BFB1-BEEBE38A6EA8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0595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745FF5-E7E1-4D35-BFB1-BEEBE38A6EA8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5D1D70-CE78-480E-9DE9-D51550A580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96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4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7" Type="http://schemas.openxmlformats.org/officeDocument/2006/relationships/image" Target="../media/image18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7" Type="http://schemas.openxmlformats.org/officeDocument/2006/relationships/image" Target="../media/image22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tiff"/><Relationship Id="rId5" Type="http://schemas.openxmlformats.org/officeDocument/2006/relationships/image" Target="../media/image20.tiff"/><Relationship Id="rId4" Type="http://schemas.openxmlformats.org/officeDocument/2006/relationships/image" Target="../media/image19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7" Type="http://schemas.openxmlformats.org/officeDocument/2006/relationships/image" Target="../media/image26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tiff"/><Relationship Id="rId5" Type="http://schemas.openxmlformats.org/officeDocument/2006/relationships/image" Target="../media/image24.tiff"/><Relationship Id="rId4" Type="http://schemas.openxmlformats.org/officeDocument/2006/relationships/image" Target="../media/image23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401688" y="105024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1813077"/>
              </p:ext>
            </p:extLst>
          </p:nvPr>
        </p:nvGraphicFramePr>
        <p:xfrm>
          <a:off x="3985116" y="1262192"/>
          <a:ext cx="1058400" cy="33542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7600">
                  <a:extLst>
                    <a:ext uri="{9D8B030D-6E8A-4147-A177-3AD203B41FA5}">
                      <a16:colId xmlns:a16="http://schemas.microsoft.com/office/drawing/2014/main" val="1086105205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2102007615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2134337286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261372518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3345070513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1588651095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4092208108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3314555622"/>
                    </a:ext>
                  </a:extLst>
                </a:gridCol>
                <a:gridCol w="117600">
                  <a:extLst>
                    <a:ext uri="{9D8B030D-6E8A-4147-A177-3AD203B41FA5}">
                      <a16:colId xmlns:a16="http://schemas.microsoft.com/office/drawing/2014/main" val="766773352"/>
                    </a:ext>
                  </a:extLst>
                </a:gridCol>
              </a:tblGrid>
              <a:tr h="111808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9593987"/>
                  </a:ext>
                </a:extLst>
              </a:tr>
              <a:tr h="111808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6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</a:t>
                      </a:r>
                      <a:endParaRPr kumimoji="0" lang="de-DE" sz="6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2206578"/>
                  </a:ext>
                </a:extLst>
              </a:tr>
              <a:tr h="111808"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de-DE" sz="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9674067"/>
                  </a:ext>
                </a:extLst>
              </a:tr>
            </a:tbl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4984741" y="1225949"/>
            <a:ext cx="63030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µM BV6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4984778" y="1328602"/>
            <a:ext cx="87395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 µM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VAD-fmk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4990171" y="1447382"/>
            <a:ext cx="89319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0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ml CD95L [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92" t="35978" r="38852" b="59275"/>
          <a:stretch/>
        </p:blipFill>
        <p:spPr>
          <a:xfrm>
            <a:off x="3984121" y="1963248"/>
            <a:ext cx="1058400" cy="11476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feld 9"/>
          <p:cNvSpPr txBox="1"/>
          <p:nvPr/>
        </p:nvSpPr>
        <p:spPr>
          <a:xfrm>
            <a:off x="5145670" y="1532237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5143936" y="1915622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42" t="36153" r="29802" b="58396"/>
          <a:stretch/>
        </p:blipFill>
        <p:spPr>
          <a:xfrm>
            <a:off x="3984060" y="2089152"/>
            <a:ext cx="1058400" cy="1317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feld 12"/>
          <p:cNvSpPr txBox="1"/>
          <p:nvPr/>
        </p:nvSpPr>
        <p:spPr>
          <a:xfrm>
            <a:off x="5158288" y="2077600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5155344" y="1659476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12" t="31933" r="32032" b="63495"/>
          <a:stretch/>
        </p:blipFill>
        <p:spPr>
          <a:xfrm>
            <a:off x="3985116" y="2233846"/>
            <a:ext cx="1058400" cy="1105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feld 15"/>
          <p:cNvSpPr txBox="1"/>
          <p:nvPr/>
        </p:nvSpPr>
        <p:spPr>
          <a:xfrm>
            <a:off x="5159344" y="2200466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790004" y="166222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790004" y="155890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3790004" y="191528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790004" y="219319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3790004" y="20579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3591864" y="1447945"/>
            <a:ext cx="4491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Gerade Verbindung mit Pfeil 22"/>
          <p:cNvCxnSpPr/>
          <p:nvPr/>
        </p:nvCxnSpPr>
        <p:spPr>
          <a:xfrm flipH="1">
            <a:off x="5059502" y="201221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/>
          <p:cNvCxnSpPr/>
          <p:nvPr/>
        </p:nvCxnSpPr>
        <p:spPr>
          <a:xfrm flipH="1">
            <a:off x="5059502" y="218016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 flipH="1">
            <a:off x="5055502" y="175217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 flipH="1">
            <a:off x="5055502" y="164062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 flipH="1">
            <a:off x="5059502" y="230506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84" t="37363" r="19560" b="59175"/>
          <a:stretch/>
        </p:blipFill>
        <p:spPr>
          <a:xfrm>
            <a:off x="3987498" y="2502153"/>
            <a:ext cx="1058400" cy="557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49" t="32933" r="21253" b="62436"/>
          <a:stretch/>
        </p:blipFill>
        <p:spPr>
          <a:xfrm>
            <a:off x="3987498" y="2416612"/>
            <a:ext cx="1058400" cy="740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98" t="33779" r="21446" b="61029"/>
          <a:stretch/>
        </p:blipFill>
        <p:spPr>
          <a:xfrm>
            <a:off x="3987498" y="2560765"/>
            <a:ext cx="1058400" cy="835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feld 30"/>
          <p:cNvSpPr txBox="1"/>
          <p:nvPr/>
        </p:nvSpPr>
        <p:spPr>
          <a:xfrm>
            <a:off x="5155983" y="2348596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5155983" y="2437816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5159344" y="2501186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Gerade Verbindung mit Pfeil 33"/>
          <p:cNvCxnSpPr/>
          <p:nvPr/>
        </p:nvCxnSpPr>
        <p:spPr>
          <a:xfrm flipH="1">
            <a:off x="5059502" y="245115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mit Pfeil 34"/>
          <p:cNvCxnSpPr/>
          <p:nvPr/>
        </p:nvCxnSpPr>
        <p:spPr>
          <a:xfrm flipH="1">
            <a:off x="5059502" y="251706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/>
          <p:cNvCxnSpPr/>
          <p:nvPr/>
        </p:nvCxnSpPr>
        <p:spPr>
          <a:xfrm flipH="1">
            <a:off x="5059502" y="259230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feld 36"/>
          <p:cNvSpPr txBox="1"/>
          <p:nvPr/>
        </p:nvSpPr>
        <p:spPr>
          <a:xfrm>
            <a:off x="3790004" y="24357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3790004" y="25093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3790004" y="23550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4366057" y="1097989"/>
            <a:ext cx="40267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T29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Grafik 4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08" t="28593" r="21541" b="66308"/>
          <a:stretch/>
        </p:blipFill>
        <p:spPr>
          <a:xfrm>
            <a:off x="3985321" y="1606350"/>
            <a:ext cx="1058400" cy="857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Grafik 4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99" t="35802" r="16951" b="57868"/>
          <a:stretch/>
        </p:blipFill>
        <p:spPr>
          <a:xfrm>
            <a:off x="3984060" y="1695237"/>
            <a:ext cx="1058400" cy="1064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Grafik 42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48" t="39143" r="18001" b="55055"/>
          <a:stretch/>
        </p:blipFill>
        <p:spPr>
          <a:xfrm>
            <a:off x="3984060" y="1801129"/>
            <a:ext cx="1058400" cy="975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4" name="Textfeld 43"/>
          <p:cNvSpPr txBox="1"/>
          <p:nvPr/>
        </p:nvSpPr>
        <p:spPr>
          <a:xfrm>
            <a:off x="5159344" y="1744566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Gerade Verbindung mit Pfeil 44"/>
          <p:cNvCxnSpPr/>
          <p:nvPr/>
        </p:nvCxnSpPr>
        <p:spPr>
          <a:xfrm flipH="1">
            <a:off x="5059502" y="184916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feld 45"/>
          <p:cNvSpPr txBox="1"/>
          <p:nvPr/>
        </p:nvSpPr>
        <p:spPr>
          <a:xfrm>
            <a:off x="3790915" y="174895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Grafik 46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7871" b="24291"/>
          <a:stretch/>
        </p:blipFill>
        <p:spPr>
          <a:xfrm>
            <a:off x="1111173" y="3324273"/>
            <a:ext cx="4581030" cy="3154511"/>
          </a:xfrm>
          <a:prstGeom prst="rect">
            <a:avLst/>
          </a:prstGeom>
        </p:spPr>
      </p:pic>
      <p:sp>
        <p:nvSpPr>
          <p:cNvPr id="48" name="Rechteck 47"/>
          <p:cNvSpPr/>
          <p:nvPr/>
        </p:nvSpPr>
        <p:spPr>
          <a:xfrm>
            <a:off x="1947056" y="337425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1896849" y="41787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1896849" y="426613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1896849" y="435749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1896849" y="445815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1896849" y="46433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1896849" y="48996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1896849" y="530957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1896849" y="55497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1896849" y="57597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1896849" y="600745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1896849" y="40186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2587334" y="3946393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1275129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1817254" y="369120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7569360" y="335319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6204020" y="33806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461588" y="39578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Gerade Verbindung mit Pfeil 16"/>
          <p:cNvCxnSpPr/>
          <p:nvPr/>
        </p:nvCxnSpPr>
        <p:spPr>
          <a:xfrm flipH="1">
            <a:off x="7469518" y="42801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/>
          <p:cNvCxnSpPr/>
          <p:nvPr/>
        </p:nvCxnSpPr>
        <p:spPr>
          <a:xfrm flipH="1">
            <a:off x="1727086" y="47751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08" t="28593" r="21541" b="66308"/>
          <a:stretch/>
        </p:blipFill>
        <p:spPr>
          <a:xfrm>
            <a:off x="656905" y="443233"/>
            <a:ext cx="1058400" cy="857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Grafik 3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99" t="35802" r="16951" b="57868"/>
          <a:stretch/>
        </p:blipFill>
        <p:spPr>
          <a:xfrm>
            <a:off x="6398076" y="371080"/>
            <a:ext cx="1058400" cy="1064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Grafik 3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705" b="24813"/>
          <a:stretch/>
        </p:blipFill>
        <p:spPr>
          <a:xfrm>
            <a:off x="222540" y="3677301"/>
            <a:ext cx="4478731" cy="3128162"/>
          </a:xfrm>
          <a:prstGeom prst="rect">
            <a:avLst/>
          </a:prstGeom>
        </p:spPr>
      </p:pic>
      <p:pic>
        <p:nvPicPr>
          <p:cNvPr id="39" name="Grafik 3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21" t="7495" r="19099" b="21823"/>
          <a:stretch/>
        </p:blipFill>
        <p:spPr>
          <a:xfrm>
            <a:off x="222540" y="662177"/>
            <a:ext cx="3189427" cy="2940711"/>
          </a:xfrm>
          <a:prstGeom prst="rect">
            <a:avLst/>
          </a:prstGeom>
        </p:spPr>
      </p:pic>
      <p:sp>
        <p:nvSpPr>
          <p:cNvPr id="40" name="Rechteck 39"/>
          <p:cNvSpPr/>
          <p:nvPr/>
        </p:nvSpPr>
        <p:spPr>
          <a:xfrm>
            <a:off x="789592" y="3870365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989764" y="45287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989764" y="46161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989764" y="47075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989764" y="48081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989764" y="49933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989764" y="52496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989764" y="56595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989764" y="58997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989764" y="61097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989764" y="63574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989764" y="43686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1680249" y="429641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pic>
        <p:nvPicPr>
          <p:cNvPr id="53" name="Grafik 5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65" t="19451" r="8952" b="18308"/>
          <a:stretch/>
        </p:blipFill>
        <p:spPr>
          <a:xfrm>
            <a:off x="5111077" y="662177"/>
            <a:ext cx="3401568" cy="2589581"/>
          </a:xfrm>
          <a:prstGeom prst="rect">
            <a:avLst/>
          </a:prstGeom>
        </p:spPr>
      </p:pic>
      <p:pic>
        <p:nvPicPr>
          <p:cNvPr id="54" name="Grafik 5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15" t="4682" r="15246" b="15495"/>
          <a:stretch/>
        </p:blipFill>
        <p:spPr>
          <a:xfrm>
            <a:off x="4869676" y="3492859"/>
            <a:ext cx="3884371" cy="3321101"/>
          </a:xfrm>
          <a:prstGeom prst="rect">
            <a:avLst/>
          </a:prstGeom>
        </p:spPr>
      </p:pic>
      <p:sp>
        <p:nvSpPr>
          <p:cNvPr id="55" name="Rechteck 54"/>
          <p:cNvSpPr/>
          <p:nvPr/>
        </p:nvSpPr>
        <p:spPr>
          <a:xfrm>
            <a:off x="4864313" y="3872753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5064485" y="45311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5064485" y="46185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5064485" y="47099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5064485" y="481056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5064485" y="499573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5064485" y="52520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5064485" y="56619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5064485" y="59021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5064485" y="61121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5064485" y="63598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5064485" y="437108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5754970" y="429879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68" name="Rechteck 67"/>
          <p:cNvSpPr/>
          <p:nvPr/>
        </p:nvSpPr>
        <p:spPr>
          <a:xfrm>
            <a:off x="656905" y="1514246"/>
            <a:ext cx="262030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9" name="Rechteck 68"/>
          <p:cNvSpPr/>
          <p:nvPr/>
        </p:nvSpPr>
        <p:spPr>
          <a:xfrm>
            <a:off x="5443188" y="1382573"/>
            <a:ext cx="262030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8212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92" t="35978" r="38852" b="59275"/>
          <a:stretch/>
        </p:blipFill>
        <p:spPr>
          <a:xfrm>
            <a:off x="6368876" y="266122"/>
            <a:ext cx="1058400" cy="11476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feld 2"/>
          <p:cNvSpPr txBox="1"/>
          <p:nvPr/>
        </p:nvSpPr>
        <p:spPr>
          <a:xfrm>
            <a:off x="7528691" y="218496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6174759" y="21815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Gerade Verbindung mit Pfeil 10"/>
          <p:cNvCxnSpPr/>
          <p:nvPr/>
        </p:nvCxnSpPr>
        <p:spPr>
          <a:xfrm flipH="1">
            <a:off x="7444257" y="31509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Grafik 2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48" t="39143" r="18001" b="55055"/>
          <a:stretch/>
        </p:blipFill>
        <p:spPr>
          <a:xfrm>
            <a:off x="641013" y="248401"/>
            <a:ext cx="1058400" cy="975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Textfeld 26"/>
          <p:cNvSpPr txBox="1"/>
          <p:nvPr/>
        </p:nvSpPr>
        <p:spPr>
          <a:xfrm>
            <a:off x="1816297" y="191838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Gerade Verbindung mit Pfeil 27"/>
          <p:cNvCxnSpPr/>
          <p:nvPr/>
        </p:nvCxnSpPr>
        <p:spPr>
          <a:xfrm flipH="1">
            <a:off x="1716455" y="29643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feld 28"/>
          <p:cNvSpPr txBox="1"/>
          <p:nvPr/>
        </p:nvSpPr>
        <p:spPr>
          <a:xfrm>
            <a:off x="447868" y="19622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54" t="13824" r="16819" b="19012"/>
          <a:stretch/>
        </p:blipFill>
        <p:spPr>
          <a:xfrm>
            <a:off x="646565" y="513977"/>
            <a:ext cx="3035808" cy="2794406"/>
          </a:xfrm>
          <a:prstGeom prst="rect">
            <a:avLst/>
          </a:prstGeom>
        </p:spPr>
      </p:pic>
      <p:pic>
        <p:nvPicPr>
          <p:cNvPr id="31" name="Grafik 3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31" t="2571" r="16295" b="20593"/>
          <a:stretch/>
        </p:blipFill>
        <p:spPr>
          <a:xfrm>
            <a:off x="447868" y="3525926"/>
            <a:ext cx="3657600" cy="3196742"/>
          </a:xfrm>
          <a:prstGeom prst="rect">
            <a:avLst/>
          </a:prstGeom>
        </p:spPr>
      </p:pic>
      <p:pic>
        <p:nvPicPr>
          <p:cNvPr id="32" name="Grafik 3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09" t="13121" r="20361" b="20593"/>
          <a:stretch/>
        </p:blipFill>
        <p:spPr>
          <a:xfrm>
            <a:off x="5098695" y="532265"/>
            <a:ext cx="3130905" cy="2757830"/>
          </a:xfrm>
          <a:prstGeom prst="rect">
            <a:avLst/>
          </a:prstGeom>
        </p:spPr>
      </p:pic>
      <p:pic>
        <p:nvPicPr>
          <p:cNvPr id="33" name="Grafik 3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705" b="21473"/>
          <a:stretch/>
        </p:blipFill>
        <p:spPr>
          <a:xfrm>
            <a:off x="4358030" y="3455517"/>
            <a:ext cx="4478731" cy="3267151"/>
          </a:xfrm>
          <a:prstGeom prst="rect">
            <a:avLst/>
          </a:prstGeom>
        </p:spPr>
      </p:pic>
      <p:sp>
        <p:nvSpPr>
          <p:cNvPr id="34" name="Rechteck 33"/>
          <p:cNvSpPr/>
          <p:nvPr/>
        </p:nvSpPr>
        <p:spPr>
          <a:xfrm>
            <a:off x="393961" y="378562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393961" y="44142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393961" y="450169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393961" y="459305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393961" y="46937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393961" y="48788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393961" y="51351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393961" y="55451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393961" y="578530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393961" y="59952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393961" y="624301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393961" y="425424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1084446" y="4181955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7" name="Rechteck 46"/>
          <p:cNvSpPr/>
          <p:nvPr/>
        </p:nvSpPr>
        <p:spPr>
          <a:xfrm>
            <a:off x="966515" y="1573949"/>
            <a:ext cx="2620305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8" name="Rechteck 47"/>
          <p:cNvSpPr/>
          <p:nvPr/>
        </p:nvSpPr>
        <p:spPr>
          <a:xfrm>
            <a:off x="5050313" y="3857562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5050313" y="44862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5050313" y="45736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5050313" y="466499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5050313" y="47656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5050313" y="49508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5050313" y="516322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5050313" y="55658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5050313" y="58572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5050313" y="606721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5050313" y="631494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5050313" y="43261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5740798" y="4253888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61" name="Rechteck 60"/>
          <p:cNvSpPr/>
          <p:nvPr/>
        </p:nvSpPr>
        <p:spPr>
          <a:xfrm>
            <a:off x="5353994" y="1463180"/>
            <a:ext cx="1858793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34834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542" t="36153" r="29802" b="58396"/>
          <a:stretch/>
        </p:blipFill>
        <p:spPr>
          <a:xfrm>
            <a:off x="787317" y="185495"/>
            <a:ext cx="1058400" cy="13176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feld 2"/>
          <p:cNvSpPr txBox="1"/>
          <p:nvPr/>
        </p:nvSpPr>
        <p:spPr>
          <a:xfrm>
            <a:off x="1961545" y="173943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12" t="31933" r="32032" b="63495"/>
          <a:stretch/>
        </p:blipFill>
        <p:spPr>
          <a:xfrm>
            <a:off x="6750262" y="317264"/>
            <a:ext cx="1058400" cy="1105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feld 4"/>
          <p:cNvSpPr txBox="1"/>
          <p:nvPr/>
        </p:nvSpPr>
        <p:spPr>
          <a:xfrm>
            <a:off x="7924490" y="283884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6555150" y="27661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93261" y="154316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Gerade Verbindung mit Pfeil 7"/>
          <p:cNvCxnSpPr/>
          <p:nvPr/>
        </p:nvCxnSpPr>
        <p:spPr>
          <a:xfrm flipH="1">
            <a:off x="1862759" y="276506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 Verbindung mit Pfeil 8"/>
          <p:cNvCxnSpPr/>
          <p:nvPr/>
        </p:nvCxnSpPr>
        <p:spPr>
          <a:xfrm flipH="1">
            <a:off x="7824648" y="38847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Grafik 2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64" t="14351" r="11049" b="18483"/>
          <a:stretch/>
        </p:blipFill>
        <p:spPr>
          <a:xfrm>
            <a:off x="728875" y="517273"/>
            <a:ext cx="3167481" cy="2794407"/>
          </a:xfrm>
          <a:prstGeom prst="rect">
            <a:avLst/>
          </a:prstGeom>
        </p:spPr>
      </p:pic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05" r="11049" b="20066"/>
          <a:stretch/>
        </p:blipFill>
        <p:spPr>
          <a:xfrm>
            <a:off x="223654" y="3429000"/>
            <a:ext cx="3862425" cy="3325673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26" t="9956" r="20098" b="19187"/>
          <a:stretch/>
        </p:blipFill>
        <p:spPr>
          <a:xfrm>
            <a:off x="5279213" y="635895"/>
            <a:ext cx="3094330" cy="2948026"/>
          </a:xfrm>
          <a:prstGeom prst="rect">
            <a:avLst/>
          </a:prstGeom>
        </p:spPr>
      </p:pic>
      <p:pic>
        <p:nvPicPr>
          <p:cNvPr id="25" name="Grafik 2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410" b="29736"/>
          <a:stretch/>
        </p:blipFill>
        <p:spPr>
          <a:xfrm>
            <a:off x="4140219" y="3831336"/>
            <a:ext cx="4829861" cy="2923337"/>
          </a:xfrm>
          <a:prstGeom prst="rect">
            <a:avLst/>
          </a:prstGeom>
        </p:spPr>
      </p:pic>
      <p:sp>
        <p:nvSpPr>
          <p:cNvPr id="26" name="Rechteck 25"/>
          <p:cNvSpPr/>
          <p:nvPr/>
        </p:nvSpPr>
        <p:spPr>
          <a:xfrm>
            <a:off x="289580" y="3835616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289580" y="446426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289580" y="45516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289580" y="46430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289580" y="47437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289580" y="49288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289580" y="51412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289580" y="55439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289580" y="58352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289580" y="604526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289580" y="62930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289580" y="430423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980065" y="423194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9" name="Rechteck 38"/>
          <p:cNvSpPr/>
          <p:nvPr/>
        </p:nvSpPr>
        <p:spPr>
          <a:xfrm>
            <a:off x="1005370" y="1417353"/>
            <a:ext cx="1858793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0" name="Rechteck 39"/>
          <p:cNvSpPr/>
          <p:nvPr/>
        </p:nvSpPr>
        <p:spPr>
          <a:xfrm>
            <a:off x="5232321" y="3886821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5232321" y="45154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5232321" y="460288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5232321" y="46942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Rechteck 43"/>
          <p:cNvSpPr/>
          <p:nvPr/>
        </p:nvSpPr>
        <p:spPr>
          <a:xfrm>
            <a:off x="5232321" y="479491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5" name="Rechteck 44"/>
          <p:cNvSpPr/>
          <p:nvPr/>
        </p:nvSpPr>
        <p:spPr>
          <a:xfrm>
            <a:off x="5232321" y="49800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5232321" y="519248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232321" y="55951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232321" y="588649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5232321" y="60964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5232321" y="634420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5232321" y="43554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5922806" y="428314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3" name="Rechteck 52"/>
          <p:cNvSpPr/>
          <p:nvPr/>
        </p:nvSpPr>
        <p:spPr>
          <a:xfrm>
            <a:off x="5864755" y="1527081"/>
            <a:ext cx="1858793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08055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84" t="37363" r="19560" b="59175"/>
          <a:stretch/>
        </p:blipFill>
        <p:spPr>
          <a:xfrm>
            <a:off x="6460035" y="271017"/>
            <a:ext cx="1058400" cy="557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49" t="32933" r="21253" b="62436"/>
          <a:stretch/>
        </p:blipFill>
        <p:spPr>
          <a:xfrm>
            <a:off x="739549" y="272627"/>
            <a:ext cx="1058400" cy="740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feld 4"/>
          <p:cNvSpPr txBox="1"/>
          <p:nvPr/>
        </p:nvSpPr>
        <p:spPr>
          <a:xfrm>
            <a:off x="1908034" y="204611"/>
            <a:ext cx="4507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7628520" y="206680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Gerade Verbindung mit Pfeil 7"/>
          <p:cNvCxnSpPr/>
          <p:nvPr/>
        </p:nvCxnSpPr>
        <p:spPr>
          <a:xfrm flipH="1">
            <a:off x="1811553" y="30717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 Verbindung mit Pfeil 8"/>
          <p:cNvCxnSpPr/>
          <p:nvPr/>
        </p:nvCxnSpPr>
        <p:spPr>
          <a:xfrm flipH="1">
            <a:off x="7532039" y="28593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feld 10"/>
          <p:cNvSpPr txBox="1"/>
          <p:nvPr/>
        </p:nvSpPr>
        <p:spPr>
          <a:xfrm>
            <a:off x="6262541" y="20461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542055" y="21105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836" b="24813"/>
          <a:stretch/>
        </p:blipFill>
        <p:spPr>
          <a:xfrm>
            <a:off x="123090" y="3587191"/>
            <a:ext cx="4471416" cy="3128162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40" t="9780" r="18918" b="25165"/>
          <a:stretch/>
        </p:blipFill>
        <p:spPr>
          <a:xfrm>
            <a:off x="306005" y="449206"/>
            <a:ext cx="3204057" cy="2706624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15" t="21913" r="17082" b="20418"/>
          <a:stretch/>
        </p:blipFill>
        <p:spPr>
          <a:xfrm>
            <a:off x="5120640" y="602825"/>
            <a:ext cx="3335731" cy="2399385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04" t="989" r="18656" b="19538"/>
          <a:stretch/>
        </p:blipFill>
        <p:spPr>
          <a:xfrm>
            <a:off x="4988967" y="3408883"/>
            <a:ext cx="3767328" cy="3306470"/>
          </a:xfrm>
          <a:prstGeom prst="rect">
            <a:avLst/>
          </a:prstGeom>
        </p:spPr>
      </p:pic>
      <p:sp>
        <p:nvSpPr>
          <p:cNvPr id="18" name="Rechteck 17"/>
          <p:cNvSpPr/>
          <p:nvPr/>
        </p:nvSpPr>
        <p:spPr>
          <a:xfrm>
            <a:off x="4988967" y="384293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4988967" y="447157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4988967" y="45589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4988967" y="46503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4988967" y="475102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4988967" y="49361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4988967" y="514859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4988967" y="55512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Rechteck 25"/>
          <p:cNvSpPr/>
          <p:nvPr/>
        </p:nvSpPr>
        <p:spPr>
          <a:xfrm>
            <a:off x="4988967" y="584260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Rechteck 26"/>
          <p:cNvSpPr/>
          <p:nvPr/>
        </p:nvSpPr>
        <p:spPr>
          <a:xfrm>
            <a:off x="4988967" y="605258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4988967" y="63003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4988967" y="43115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5679452" y="4239256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31" name="Rechteck 30"/>
          <p:cNvSpPr/>
          <p:nvPr/>
        </p:nvSpPr>
        <p:spPr>
          <a:xfrm>
            <a:off x="5604372" y="1209785"/>
            <a:ext cx="2654489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2" name="Rechteck 31"/>
          <p:cNvSpPr/>
          <p:nvPr/>
        </p:nvSpPr>
        <p:spPr>
          <a:xfrm>
            <a:off x="835395" y="385576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835395" y="44844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835395" y="457182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835395" y="466319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835395" y="47638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835395" y="49490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835395" y="51614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835395" y="55640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835395" y="585543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835395" y="60654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835395" y="63131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Rechteck 42"/>
          <p:cNvSpPr/>
          <p:nvPr/>
        </p:nvSpPr>
        <p:spPr>
          <a:xfrm>
            <a:off x="835395" y="43243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1525880" y="425209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5" name="Rechteck 44"/>
          <p:cNvSpPr/>
          <p:nvPr/>
        </p:nvSpPr>
        <p:spPr>
          <a:xfrm>
            <a:off x="670702" y="1359082"/>
            <a:ext cx="2657714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0478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98" t="33779" r="21446" b="61029"/>
          <a:stretch/>
        </p:blipFill>
        <p:spPr>
          <a:xfrm>
            <a:off x="629821" y="571031"/>
            <a:ext cx="1058400" cy="8355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feld 2"/>
          <p:cNvSpPr txBox="1"/>
          <p:nvPr/>
        </p:nvSpPr>
        <p:spPr>
          <a:xfrm>
            <a:off x="1801667" y="511452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Gerade Verbindung mit Pfeil 3"/>
          <p:cNvCxnSpPr/>
          <p:nvPr/>
        </p:nvCxnSpPr>
        <p:spPr>
          <a:xfrm flipH="1">
            <a:off x="1701825" y="60256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feld 4"/>
          <p:cNvSpPr txBox="1"/>
          <p:nvPr/>
        </p:nvSpPr>
        <p:spPr>
          <a:xfrm>
            <a:off x="432327" y="51962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885" b="27978"/>
          <a:stretch/>
        </p:blipFill>
        <p:spPr>
          <a:xfrm>
            <a:off x="490117" y="3816584"/>
            <a:ext cx="4412894" cy="2996489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39" t="13122" r="13672" b="27226"/>
          <a:stretch/>
        </p:blipFill>
        <p:spPr>
          <a:xfrm>
            <a:off x="490117" y="795407"/>
            <a:ext cx="3496665" cy="2481803"/>
          </a:xfrm>
          <a:prstGeom prst="rect">
            <a:avLst/>
          </a:prstGeom>
        </p:spPr>
      </p:pic>
      <p:sp>
        <p:nvSpPr>
          <p:cNvPr id="8" name="Rechteck 7"/>
          <p:cNvSpPr/>
          <p:nvPr/>
        </p:nvSpPr>
        <p:spPr>
          <a:xfrm>
            <a:off x="1192378" y="398191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9" name="Rechteck 8"/>
          <p:cNvSpPr/>
          <p:nvPr/>
        </p:nvSpPr>
        <p:spPr>
          <a:xfrm>
            <a:off x="1192378" y="46105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" name="Rechteck 9"/>
          <p:cNvSpPr/>
          <p:nvPr/>
        </p:nvSpPr>
        <p:spPr>
          <a:xfrm>
            <a:off x="1192378" y="469798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" name="Rechteck 10"/>
          <p:cNvSpPr/>
          <p:nvPr/>
        </p:nvSpPr>
        <p:spPr>
          <a:xfrm>
            <a:off x="1192378" y="47893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1192378" y="48900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3" name="Rechteck 12"/>
          <p:cNvSpPr/>
          <p:nvPr/>
        </p:nvSpPr>
        <p:spPr>
          <a:xfrm>
            <a:off x="1192378" y="50751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4" name="Rechteck 13"/>
          <p:cNvSpPr/>
          <p:nvPr/>
        </p:nvSpPr>
        <p:spPr>
          <a:xfrm>
            <a:off x="1192378" y="528758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1192378" y="569021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1192378" y="59815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1192378" y="61915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1192378" y="64393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1192378" y="445053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882863" y="437824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1" name="Rechteck 20"/>
          <p:cNvSpPr/>
          <p:nvPr/>
        </p:nvSpPr>
        <p:spPr>
          <a:xfrm>
            <a:off x="822594" y="1658754"/>
            <a:ext cx="2654489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50304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97</Words>
  <Application>Microsoft Office PowerPoint</Application>
  <PresentationFormat>Bildschirmpräsentation (4:3)</PresentationFormat>
  <Paragraphs>199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5</cp:revision>
  <dcterms:created xsi:type="dcterms:W3CDTF">2024-08-16T12:56:00Z</dcterms:created>
  <dcterms:modified xsi:type="dcterms:W3CDTF">2025-01-21T14:06:48Z</dcterms:modified>
</cp:coreProperties>
</file>